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  <p:sldId id="266" r:id="rId4"/>
    <p:sldId id="268" r:id="rId5"/>
    <p:sldId id="26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59C4E4-40C8-429F-A904-721044FE3C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F266E0-03B1-4F51-939D-626EBE42D4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11BF92-8986-48FE-9593-8179F2A14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77271-AC51-4222-A0B7-DB92C251E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63376-2E26-47F8-B14E-37B6DACD9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609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9E7623-FE37-4CE4-9FFE-B59C41544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E2745B-5F38-45C8-BF80-277954A896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E39940-6E1A-4168-A343-CA13897B0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965F78-5F8E-47D3-8FFA-A4A3C6C83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CFFBB-3830-46AA-BD08-9226A9082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9443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178C0B-C7A2-4DE3-9E6B-FECD7C7C04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D30C7A-3006-470C-96BD-D4B61E486C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87D568-D83D-4CB8-B0F6-9978C07B8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38C90F-C1D5-4DB8-A7B1-361097F9A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B51684-C56A-45A1-8064-8C52DBC86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13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3A60B-2151-467C-8F80-6970EB0E7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E7933-3ADC-40C4-ABCD-B6DDAE311F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3844DC-EC9B-44E9-8E43-D4A74D91C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07A4D4-CEE1-46E9-973F-A68A1738A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FC2F9D-1A87-49F9-819E-7B33558C1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1146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CE5631-89E0-4C09-AB1D-06D4C9019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35B861-CC96-4707-96C3-03358DC818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0E971B-9B28-4667-A1D2-61D3DB970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C9C699-177B-4BB2-84A8-5BFAB508A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35DCB-3F6B-47DB-8651-936476E3A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2665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FFC3F0-9AF5-45E7-9BAA-CBC1DACF1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824599-B7E9-4721-8C71-7DEE0EBFB0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972ED8-8701-47DA-85E3-57C1F89E12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DD21A5-6D2D-4EF5-975F-432791DFC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44C017-5C89-419D-8B51-FCD29CB46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961585-CA5D-447D-A092-B8DC08B96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085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BBE0E0-2036-472F-9DB5-771C245999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49F16B-B497-4C28-ABE3-26C5C37CF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88F276-9DAA-447D-AFB8-9C808F314F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F82B66-7EAD-4824-9BA3-5D8226986A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90948E-7A99-4479-BAA7-1571D3BB60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AB183A-626A-49EC-A6CD-5040883A7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68AB83B-2595-4433-B9A7-31EB6AAA6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37A07C-F53B-4103-A14E-9B9E4D09F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9442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8BBFEA-8F6D-4224-B4DE-B8032B224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9627C4-3CE7-4808-8A7C-B758892FF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965ABC-FBB6-461F-87B7-6CCE17F26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9F9D20-EF41-4EB8-BDA9-A26B5109F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810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B904A1-B457-4A76-ABB3-7BBA2EDEF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E14CBE1-0A8C-4B71-8C21-804199255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A9D710-D290-4D78-8E20-A9EF7A312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636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1B0D0-7582-4121-89E8-E80298F3C0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3F0A3E-5EB8-4183-9C73-EE12CF2E21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1B0BA8-9AB3-4F6C-AF31-A3974984E7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24A577-5860-4FF7-A1C4-A7EE7FD3E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397349-D733-4CEC-94AC-B6BF1A444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7AF237-D2CE-4CD5-9DFF-E6A109A89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458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BA867B-73A4-4E78-9485-2711D946B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9AC3-96EF-4C69-BE8A-98175C7E27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F61079-9103-4B56-B5E0-27B937C921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E10730-4B0B-4753-8CF6-DE8442F84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5A23E1-1FE9-41F4-BEFE-4455DC6EC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867B36-B72C-4407-84F2-FD8378620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633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572BC4-9F32-4F82-87BC-84825E2DB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3338C3-8566-4F4F-8FC3-F76B74535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D05F08-42AF-4403-A879-DF47E7F628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1F62B-604B-4088-88CF-4736C4CD6FCE}" type="datetimeFigureOut">
              <a:rPr lang="en-GB" smtClean="0"/>
              <a:t>01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92FCCD-A9C7-44B7-91E7-5A61F53211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2F0E4F-0A2B-4BF3-98C4-73C903D67C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C3A909-65BD-4E5E-9BC5-D6BB2285C5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825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742C131-56EE-4EB8-8A70-F21113640C69}"/>
              </a:ext>
            </a:extLst>
          </p:cNvPr>
          <p:cNvSpPr txBox="1"/>
          <p:nvPr/>
        </p:nvSpPr>
        <p:spPr>
          <a:xfrm>
            <a:off x="4631634" y="0"/>
            <a:ext cx="29287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upplementary Figur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2810F03-C4A5-40E0-8D86-C23DA95D110E}"/>
              </a:ext>
            </a:extLst>
          </p:cNvPr>
          <p:cNvSpPr txBox="1"/>
          <p:nvPr/>
        </p:nvSpPr>
        <p:spPr>
          <a:xfrm>
            <a:off x="518421" y="1048656"/>
            <a:ext cx="40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8CAA8E-F816-4FD3-A9DF-9A6EC4DBD790}"/>
              </a:ext>
            </a:extLst>
          </p:cNvPr>
          <p:cNvSpPr txBox="1"/>
          <p:nvPr/>
        </p:nvSpPr>
        <p:spPr>
          <a:xfrm>
            <a:off x="6583659" y="1048656"/>
            <a:ext cx="40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DC144624-CF9A-44D3-A574-E391FCCD125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8446" y="1233322"/>
          <a:ext cx="4889897" cy="36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713719" imgH="2733569" progId="Prism8.Document">
                  <p:embed/>
                </p:oleObj>
              </mc:Choice>
              <mc:Fallback>
                <p:oleObj name="Prism 8" r:id="rId2" imgW="3713719" imgH="2733569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DC144624-CF9A-44D3-A574-E391FCCD12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18446" y="1233322"/>
                        <a:ext cx="4889897" cy="36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06CDCBE-D603-4BE3-B460-EB6C872D6F3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83659" y="1233322"/>
          <a:ext cx="4752649" cy="36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718401" imgH="2816044" progId="Prism8.Document">
                  <p:embed/>
                </p:oleObj>
              </mc:Choice>
              <mc:Fallback>
                <p:oleObj name="Prism 8" r:id="rId4" imgW="3718401" imgH="2816044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06CDCBE-D603-4BE3-B460-EB6C872D6F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583659" y="1233322"/>
                        <a:ext cx="4752649" cy="36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E5B2C125-4481-4EEF-96C5-328CE35F84A3}"/>
              </a:ext>
            </a:extLst>
          </p:cNvPr>
          <p:cNvSpPr txBox="1"/>
          <p:nvPr/>
        </p:nvSpPr>
        <p:spPr>
          <a:xfrm>
            <a:off x="718446" y="5344233"/>
            <a:ext cx="107579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iveness to external stimuli evoking insulin release from clonal pancreatic BRIN-BD11 beta-cells at basal, 5.6 mM (A), and elevated, 16.7 mM (B), glucose concentration. Positive controls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Cl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30 mM) and GLP-1(7-36) (10</a:t>
            </a:r>
            <a:r>
              <a:rPr lang="en-GB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6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were also employed. Values are mean ± SEM (n=8). *P&lt;0.05, **P&lt;0.01, ***P&lt;0.001 compared to 5.6 mM (A) or 16.7 mM (B) glucose-only controls . </a:t>
            </a:r>
          </a:p>
        </p:txBody>
      </p:sp>
    </p:spTree>
    <p:extLst>
      <p:ext uri="{BB962C8B-B14F-4D97-AF65-F5344CB8AC3E}">
        <p14:creationId xmlns:p14="http://schemas.microsoft.com/office/powerpoint/2010/main" val="451105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33A8079-5D0B-47E3-9099-7045D95E05A8}"/>
              </a:ext>
            </a:extLst>
          </p:cNvPr>
          <p:cNvSpPr txBox="1"/>
          <p:nvPr/>
        </p:nvSpPr>
        <p:spPr>
          <a:xfrm>
            <a:off x="4631634" y="0"/>
            <a:ext cx="29287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upplementary Figure 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BAB803E-AD5C-40D1-B8D5-D4C7F53699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9512" y="604388"/>
            <a:ext cx="8292974" cy="46082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B82C1C6-BAE0-4D39-943F-FC5BFAA2712E}"/>
              </a:ext>
            </a:extLst>
          </p:cNvPr>
          <p:cNvSpPr txBox="1"/>
          <p:nvPr/>
        </p:nvSpPr>
        <p:spPr>
          <a:xfrm>
            <a:off x="718446" y="5344233"/>
            <a:ext cx="107579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iveness of DPP-4 assay utilising increasing concentrations (2.5 – 200 µM) of the enzyme inhibitor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protin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against a fixed enzyme concentration (8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. Values are mean ± SEM (n=3). *P&lt;0.05, **P&lt;0.01, ***P&lt;0.001 compared to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o AMC + DPP-4-only control. </a:t>
            </a:r>
          </a:p>
        </p:txBody>
      </p:sp>
    </p:spTree>
    <p:extLst>
      <p:ext uri="{BB962C8B-B14F-4D97-AF65-F5344CB8AC3E}">
        <p14:creationId xmlns:p14="http://schemas.microsoft.com/office/powerpoint/2010/main" val="8380662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7C10C5A-7A56-4079-8532-48A01590AA6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316136"/>
          <a:ext cx="6289675" cy="337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289050" imgH="3375724" progId="Prism8.Document">
                  <p:embed/>
                </p:oleObj>
              </mc:Choice>
              <mc:Fallback>
                <p:oleObj name="Prism 8" r:id="rId2" imgW="6289050" imgH="3375724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F7C10C5A-7A56-4079-8532-48A01590AA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316136"/>
                        <a:ext cx="6289675" cy="337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178B38B-B49A-402C-9861-C532D6CA336D}"/>
              </a:ext>
            </a:extLst>
          </p:cNvPr>
          <p:cNvSpPr txBox="1"/>
          <p:nvPr/>
        </p:nvSpPr>
        <p:spPr>
          <a:xfrm>
            <a:off x="4631634" y="0"/>
            <a:ext cx="29287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upplementary Figure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3E559A-3190-4FBB-9B83-C512621F23BD}"/>
              </a:ext>
            </a:extLst>
          </p:cNvPr>
          <p:cNvSpPr txBox="1"/>
          <p:nvPr/>
        </p:nvSpPr>
        <p:spPr>
          <a:xfrm>
            <a:off x="34002" y="398749"/>
            <a:ext cx="40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3FED72-5D69-47E6-A2CA-2893F26AC09E}"/>
              </a:ext>
            </a:extLst>
          </p:cNvPr>
          <p:cNvSpPr txBox="1"/>
          <p:nvPr/>
        </p:nvSpPr>
        <p:spPr>
          <a:xfrm>
            <a:off x="6095999" y="398749"/>
            <a:ext cx="40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0A42C2-326C-467A-8FE7-381A1A4A33DF}"/>
              </a:ext>
            </a:extLst>
          </p:cNvPr>
          <p:cNvSpPr txBox="1"/>
          <p:nvPr/>
        </p:nvSpPr>
        <p:spPr>
          <a:xfrm>
            <a:off x="34002" y="3429000"/>
            <a:ext cx="400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7C3CF9D-586B-42A8-B565-8A241A5A5B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89675" y="316136"/>
          <a:ext cx="4994275" cy="368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994362" imgH="3687977" progId="Prism8.Document">
                  <p:embed/>
                </p:oleObj>
              </mc:Choice>
              <mc:Fallback>
                <p:oleObj name="Prism 8" r:id="rId4" imgW="4994362" imgH="3687977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7C3CF9D-586B-42A8-B565-8A241A5A5B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89675" y="316136"/>
                        <a:ext cx="4994275" cy="368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E134A35-7CA9-4D4C-95AE-AB2F142601CB}"/>
              </a:ext>
            </a:extLst>
          </p:cNvPr>
          <p:cNvGraphicFramePr>
            <a:graphicFrameLocks/>
          </p:cNvGraphicFramePr>
          <p:nvPr/>
        </p:nvGraphicFramePr>
        <p:xfrm>
          <a:off x="57150" y="3438525"/>
          <a:ext cx="4370388" cy="3419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645294" imgH="3857250" progId="Prism8.Document">
                  <p:embed/>
                </p:oleObj>
              </mc:Choice>
              <mc:Fallback>
                <p:oleObj name="Prism 8" r:id="rId6" imgW="3645294" imgH="3857250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FE134A35-7CA9-4D4C-95AE-AB2F142601C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7150" y="3438525"/>
                        <a:ext cx="4370388" cy="3419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D323993-413F-4095-AA09-6C0D6F1F43D7}"/>
              </a:ext>
            </a:extLst>
          </p:cNvPr>
          <p:cNvSpPr txBox="1"/>
          <p:nvPr/>
        </p:nvSpPr>
        <p:spPr>
          <a:xfrm>
            <a:off x="4580515" y="4003899"/>
            <a:ext cx="739876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 responses for the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ria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t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ydrolysate ULPH020, with relation to glucose tolerance (A,B) and cumulative food intake over a 3 hour period. Glucose tolerance was assessed in lean, overnight-fasted (16 h) NIH Swiss mice and (C) acute food intake in lean, diet-restricted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D:Ol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0 mice. Animals (n=8) received glucose (18.8 mmol/kg/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w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one or in combination with hydrolysate, at 50 and 100 mg/kg/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w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A,B) or saline (0.9% NaCl) alone or in combination with hydrolysate, at 25, 50 or 100 mg/kg/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w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via oral gavage (C). Additionally, known satiating peptides (PYY(3-36) and oxytocin) were employed as positive controls, given as an intraperitoneal dose of 25 nmol/kg/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w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. Values are mean ± SEM (n=8). *P&lt;0.05, **P&lt;0.01, ***P&lt;0.001 compared to glucose only (A,B) or saline only (C) controls. </a:t>
            </a:r>
          </a:p>
        </p:txBody>
      </p:sp>
    </p:spTree>
    <p:extLst>
      <p:ext uri="{BB962C8B-B14F-4D97-AF65-F5344CB8AC3E}">
        <p14:creationId xmlns:p14="http://schemas.microsoft.com/office/powerpoint/2010/main" val="19154432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48D60EF-1B93-4710-B792-91F9AF30A100}"/>
              </a:ext>
            </a:extLst>
          </p:cNvPr>
          <p:cNvSpPr txBox="1"/>
          <p:nvPr/>
        </p:nvSpPr>
        <p:spPr>
          <a:xfrm>
            <a:off x="4631634" y="0"/>
            <a:ext cx="29287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upplementary Figure 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92644F0-3BAB-48B7-ABC4-0C4560C8AE16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400110"/>
            <a:ext cx="5641145" cy="6211705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8362011-CA06-4E1C-90CB-A0615B340F7B}"/>
              </a:ext>
            </a:extLst>
          </p:cNvPr>
          <p:cNvSpPr txBox="1"/>
          <p:nvPr/>
        </p:nvSpPr>
        <p:spPr>
          <a:xfrm>
            <a:off x="5834423" y="510310"/>
            <a:ext cx="5528603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l permeation HPLC profiles showing the molecular mass distribution of the soluble proteinaceous components in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ri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t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hydrolysates and their simulated gastrointestinal digests (SGID). PPPH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ri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lmata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hydrolysate, Con: control, AF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alas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vourzym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alas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rom: Bromelain, Prom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o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ines show the retention time at 1, 2, 5 and 10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8569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DD7B884-31B9-4C9B-A7CE-7463E0B89EA4}"/>
              </a:ext>
            </a:extLst>
          </p:cNvPr>
          <p:cNvSpPr txBox="1"/>
          <p:nvPr/>
        </p:nvSpPr>
        <p:spPr>
          <a:xfrm>
            <a:off x="0" y="0"/>
            <a:ext cx="12192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upplementary Table 1. </a:t>
            </a:r>
            <a:r>
              <a:rPr lang="en-GB" sz="2000" dirty="0"/>
              <a:t>Extent of hydrolysis and molecular mass (Mw) distribution of the soluble proteinaceous components in </a:t>
            </a:r>
            <a:r>
              <a:rPr lang="en-GB" sz="2000" dirty="0" err="1"/>
              <a:t>Palmaria</a:t>
            </a:r>
            <a:r>
              <a:rPr lang="en-GB" sz="2000" dirty="0"/>
              <a:t> </a:t>
            </a:r>
            <a:r>
              <a:rPr lang="en-GB" sz="2000" dirty="0" err="1"/>
              <a:t>palmata</a:t>
            </a:r>
            <a:r>
              <a:rPr lang="en-GB" sz="2000" dirty="0"/>
              <a:t> protein hydrolysates and their simulated gastrointestinal digests (SGID)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B6C5A0F-DD94-4A49-9684-AE5C7FE14EF9}"/>
              </a:ext>
            </a:extLst>
          </p:cNvPr>
          <p:cNvGraphicFramePr>
            <a:graphicFrameLocks noGrp="1"/>
          </p:cNvGraphicFramePr>
          <p:nvPr/>
        </p:nvGraphicFramePr>
        <p:xfrm>
          <a:off x="543339" y="1118703"/>
          <a:ext cx="11105321" cy="3551583"/>
        </p:xfrm>
        <a:graphic>
          <a:graphicData uri="http://schemas.openxmlformats.org/drawingml/2006/table">
            <a:tbl>
              <a:tblPr firstRow="1" firstCol="1" bandRow="1"/>
              <a:tblGrid>
                <a:gridCol w="565556">
                  <a:extLst>
                    <a:ext uri="{9D8B030D-6E8A-4147-A177-3AD203B41FA5}">
                      <a16:colId xmlns:a16="http://schemas.microsoft.com/office/drawing/2014/main" val="3074718182"/>
                    </a:ext>
                  </a:extLst>
                </a:gridCol>
                <a:gridCol w="678827">
                  <a:extLst>
                    <a:ext uri="{9D8B030D-6E8A-4147-A177-3AD203B41FA5}">
                      <a16:colId xmlns:a16="http://schemas.microsoft.com/office/drawing/2014/main" val="2236901090"/>
                    </a:ext>
                  </a:extLst>
                </a:gridCol>
                <a:gridCol w="791299">
                  <a:extLst>
                    <a:ext uri="{9D8B030D-6E8A-4147-A177-3AD203B41FA5}">
                      <a16:colId xmlns:a16="http://schemas.microsoft.com/office/drawing/2014/main" val="2342910811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3312876153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753923549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3533402990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1331520864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3867169103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1660957952"/>
                    </a:ext>
                  </a:extLst>
                </a:gridCol>
                <a:gridCol w="1352070">
                  <a:extLst>
                    <a:ext uri="{9D8B030D-6E8A-4147-A177-3AD203B41FA5}">
                      <a16:colId xmlns:a16="http://schemas.microsoft.com/office/drawing/2014/main" val="552384480"/>
                    </a:ext>
                  </a:extLst>
                </a:gridCol>
                <a:gridCol w="1352070">
                  <a:extLst>
                    <a:ext uri="{9D8B030D-6E8A-4147-A177-3AD203B41FA5}">
                      <a16:colId xmlns:a16="http://schemas.microsoft.com/office/drawing/2014/main" val="2384617970"/>
                    </a:ext>
                  </a:extLst>
                </a:gridCol>
                <a:gridCol w="909357">
                  <a:extLst>
                    <a:ext uri="{9D8B030D-6E8A-4147-A177-3AD203B41FA5}">
                      <a16:colId xmlns:a16="http://schemas.microsoft.com/office/drawing/2014/main" val="1024851779"/>
                    </a:ext>
                  </a:extLst>
                </a:gridCol>
              </a:tblGrid>
              <a:tr h="468995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eolytic enzyme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:SGI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:SGI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c:SGI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ro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rom:SGI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m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E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m:SGID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4345812"/>
                  </a:ext>
                </a:extLst>
              </a:tr>
              <a:tr h="949766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ent of hydrolysis (mg amino N/g protein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73 ± 0.3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22 ± 0.95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43 ± 0.8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.28 ± 1.38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02 ± 1.3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.75 ± 0.90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19 ± 0.7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42 ± 1.26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78 ± 1.0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80 ± 1.14</a:t>
                      </a:r>
                      <a:r>
                        <a:rPr lang="en-GB" sz="1200" b="1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306222"/>
                  </a:ext>
                </a:extLst>
              </a:tr>
              <a:tr h="4689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gt;10kDa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9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99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3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2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.3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8.8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443783"/>
                  </a:ext>
                </a:extLst>
              </a:tr>
              <a:tr h="3837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-10Da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48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5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71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4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3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0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9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4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7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3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7060677"/>
                  </a:ext>
                </a:extLst>
              </a:tr>
              <a:tr h="51265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GB" sz="1200" b="1" baseline="-25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</a:t>
                      </a: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ang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-5kDa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3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9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.0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51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4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2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5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2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2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.7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1890475"/>
                  </a:ext>
                </a:extLst>
              </a:tr>
              <a:tr h="3837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-2kDa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0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5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6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1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.83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10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16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24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49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7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120983"/>
                  </a:ext>
                </a:extLst>
              </a:tr>
              <a:tr h="3837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1kDa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.1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3.97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4.8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8.7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6.1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.38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.9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7.7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7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8.72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385208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3BCF5C4-088F-46EE-81D1-4E89C782656B}"/>
              </a:ext>
            </a:extLst>
          </p:cNvPr>
          <p:cNvSpPr txBox="1"/>
          <p:nvPr/>
        </p:nvSpPr>
        <p:spPr>
          <a:xfrm>
            <a:off x="384313" y="4996070"/>
            <a:ext cx="114366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± SD (n=3) Con: aqueous/alkaline control, AF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alas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vourzym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alase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rom: bromelain, Prom: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o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 indicates a significant difference (P&lt;0.05) in extent of hydrolysis value following SGID.</a:t>
            </a:r>
          </a:p>
        </p:txBody>
      </p:sp>
    </p:spTree>
    <p:extLst>
      <p:ext uri="{BB962C8B-B14F-4D97-AF65-F5344CB8AC3E}">
        <p14:creationId xmlns:p14="http://schemas.microsoft.com/office/powerpoint/2010/main" val="2762097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657</Words>
  <Application>Microsoft Office PowerPoint</Application>
  <PresentationFormat>Widescreen</PresentationFormat>
  <Paragraphs>97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fferty, Ryan</dc:creator>
  <cp:lastModifiedBy>O'Harte, Finbarr</cp:lastModifiedBy>
  <cp:revision>4</cp:revision>
  <dcterms:created xsi:type="dcterms:W3CDTF">2021-01-20T10:35:32Z</dcterms:created>
  <dcterms:modified xsi:type="dcterms:W3CDTF">2021-02-01T19:32:03Z</dcterms:modified>
</cp:coreProperties>
</file>